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18288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57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7481" autoAdjust="0"/>
  </p:normalViewPr>
  <p:slideViewPr>
    <p:cSldViewPr>
      <p:cViewPr varScale="1">
        <p:scale>
          <a:sx n="53" d="100"/>
          <a:sy n="53" d="100"/>
        </p:scale>
        <p:origin x="96" y="666"/>
      </p:cViewPr>
      <p:guideLst>
        <p:guide orient="horz" pos="2160"/>
        <p:guide pos="57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2</c:f>
                <c:numCache>
                  <c:formatCode>General</c:formatCode>
                  <c:ptCount val="11"/>
                  <c:pt idx="0">
                    <c:v>19.642600000000002</c:v>
                  </c:pt>
                  <c:pt idx="1">
                    <c:v>11.443199999999999</c:v>
                  </c:pt>
                  <c:pt idx="2">
                    <c:v>14.1683</c:v>
                  </c:pt>
                  <c:pt idx="3">
                    <c:v>24.1935</c:v>
                  </c:pt>
                  <c:pt idx="4">
                    <c:v>55.515000000000001</c:v>
                  </c:pt>
                </c:numCache>
              </c:numRef>
            </c:plus>
            <c:minus>
              <c:numRef>
                <c:f>Sheet2!$F$2:$F$12</c:f>
                <c:numCache>
                  <c:formatCode>General</c:formatCode>
                  <c:ptCount val="11"/>
                  <c:pt idx="0">
                    <c:v>19.642600000000002</c:v>
                  </c:pt>
                  <c:pt idx="1">
                    <c:v>11.443199999999999</c:v>
                  </c:pt>
                  <c:pt idx="2">
                    <c:v>14.1683</c:v>
                  </c:pt>
                  <c:pt idx="3">
                    <c:v>24.1935</c:v>
                  </c:pt>
                  <c:pt idx="4">
                    <c:v>55.515000000000001</c:v>
                  </c:pt>
                </c:numCache>
              </c:numRef>
            </c:minus>
          </c:errBars>
          <c:xVal>
            <c:numRef>
              <c:f>Sheet2!$J$2:$J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  <c:pt idx="4">
                  <c:v>4.3</c:v>
                </c:pt>
              </c:numCache>
            </c:numRef>
          </c:xVal>
          <c:yVal>
            <c:numRef>
              <c:f>Sheet2!$B$2:$B$12</c:f>
              <c:numCache>
                <c:formatCode>General</c:formatCode>
                <c:ptCount val="11"/>
                <c:pt idx="0">
                  <c:v>50.089500000000001</c:v>
                </c:pt>
                <c:pt idx="1">
                  <c:v>-6.9032999999999998</c:v>
                </c:pt>
                <c:pt idx="2">
                  <c:v>-44.284599999999998</c:v>
                </c:pt>
                <c:pt idx="3">
                  <c:v>-117.958</c:v>
                </c:pt>
                <c:pt idx="4">
                  <c:v>-317.783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6BE-4C03-B429-2E6E50C53341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2</c:f>
                <c:numCache>
                  <c:formatCode>General</c:formatCode>
                  <c:ptCount val="11"/>
                  <c:pt idx="0">
                    <c:v>16.927099999999999</c:v>
                  </c:pt>
                  <c:pt idx="1">
                    <c:v>10.6442</c:v>
                  </c:pt>
                  <c:pt idx="2">
                    <c:v>15.933999999999999</c:v>
                  </c:pt>
                  <c:pt idx="3">
                    <c:v>31.581099999999999</c:v>
                  </c:pt>
                  <c:pt idx="4">
                    <c:v>117.2299</c:v>
                  </c:pt>
                </c:numCache>
              </c:numRef>
            </c:plus>
            <c:minus>
              <c:numRef>
                <c:f>Sheet2!$G$2:$G$12</c:f>
                <c:numCache>
                  <c:formatCode>General</c:formatCode>
                  <c:ptCount val="11"/>
                  <c:pt idx="0">
                    <c:v>16.927099999999999</c:v>
                  </c:pt>
                  <c:pt idx="1">
                    <c:v>10.6442</c:v>
                  </c:pt>
                  <c:pt idx="2">
                    <c:v>15.933999999999999</c:v>
                  </c:pt>
                  <c:pt idx="3">
                    <c:v>31.581099999999999</c:v>
                  </c:pt>
                  <c:pt idx="4">
                    <c:v>117.2299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</c:numCache>
            </c:numRef>
          </c:xVal>
          <c:yVal>
            <c:numRef>
              <c:f>Sheet2!$C$2:$C$12</c:f>
              <c:numCache>
                <c:formatCode>General</c:formatCode>
                <c:ptCount val="11"/>
                <c:pt idx="0">
                  <c:v>67.499799999999993</c:v>
                </c:pt>
                <c:pt idx="1">
                  <c:v>23.572399999999998</c:v>
                </c:pt>
                <c:pt idx="2">
                  <c:v>-23.799600000000002</c:v>
                </c:pt>
                <c:pt idx="3">
                  <c:v>-87.103899999999996</c:v>
                </c:pt>
                <c:pt idx="4">
                  <c:v>-239.229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6BE-4C03-B429-2E6E50C53341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 no bolus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12</c:f>
                <c:numCache>
                  <c:formatCode>General</c:formatCode>
                  <c:ptCount val="11"/>
                  <c:pt idx="0">
                    <c:v>21.974799999999998</c:v>
                  </c:pt>
                  <c:pt idx="1">
                    <c:v>15.475099999999999</c:v>
                  </c:pt>
                  <c:pt idx="2">
                    <c:v>28.6493</c:v>
                  </c:pt>
                  <c:pt idx="3">
                    <c:v>62.754300000000001</c:v>
                  </c:pt>
                  <c:pt idx="4">
                    <c:v>139.4171</c:v>
                  </c:pt>
                </c:numCache>
              </c:numRef>
            </c:plus>
            <c:minus>
              <c:numRef>
                <c:f>Sheet2!$H$2:$H$12</c:f>
                <c:numCache>
                  <c:formatCode>General</c:formatCode>
                  <c:ptCount val="11"/>
                  <c:pt idx="0">
                    <c:v>21.974799999999998</c:v>
                  </c:pt>
                  <c:pt idx="1">
                    <c:v>15.475099999999999</c:v>
                  </c:pt>
                  <c:pt idx="2">
                    <c:v>28.6493</c:v>
                  </c:pt>
                  <c:pt idx="3">
                    <c:v>62.754300000000001</c:v>
                  </c:pt>
                  <c:pt idx="4">
                    <c:v>139.4171</c:v>
                  </c:pt>
                </c:numCache>
              </c:numRef>
            </c:minus>
          </c:errBars>
          <c:xVal>
            <c:numRef>
              <c:f>Sheet2!$L$2:$L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  <c:pt idx="4">
                  <c:v>4.7</c:v>
                </c:pt>
              </c:numCache>
            </c:numRef>
          </c:xVal>
          <c:yVal>
            <c:numRef>
              <c:f>Sheet2!$D$2:$D$12</c:f>
              <c:numCache>
                <c:formatCode>General</c:formatCode>
                <c:ptCount val="11"/>
                <c:pt idx="0">
                  <c:v>144.1849</c:v>
                </c:pt>
                <c:pt idx="1">
                  <c:v>128.68219999999999</c:v>
                </c:pt>
                <c:pt idx="2">
                  <c:v>100.2912</c:v>
                </c:pt>
                <c:pt idx="3">
                  <c:v>86.436599999999999</c:v>
                </c:pt>
                <c:pt idx="4">
                  <c:v>-305.968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6BE-4C03-B429-2E6E50C53341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circle"/>
            <c:size val="9"/>
          </c:marker>
          <c:errBars>
            <c:errDir val="y"/>
            <c:errBarType val="both"/>
            <c:errValType val="cust"/>
            <c:noEndCap val="0"/>
            <c:plus>
              <c:numRef>
                <c:f>Sheet2!$I$2:$I$12</c:f>
                <c:numCache>
                  <c:formatCode>General</c:formatCode>
                  <c:ptCount val="11"/>
                </c:numCache>
              </c:numRef>
            </c:plus>
            <c:minus>
              <c:numRef>
                <c:f>Sheet2!$I$2:$I$12</c:f>
                <c:numCache>
                  <c:formatCode>General</c:formatCode>
                  <c:ptCount val="11"/>
                </c:numCache>
              </c:numRef>
            </c:minus>
          </c:errBars>
          <c:xVal>
            <c:numRef>
              <c:f>Sheet2!$M$2:$M$17</c:f>
              <c:numCache>
                <c:formatCode>General</c:formatCode>
                <c:ptCount val="16"/>
              </c:numCache>
            </c:numRef>
          </c:xVal>
          <c:yVal>
            <c:numRef>
              <c:f>Sheet2!$I$2:$I$12</c:f>
              <c:numCache>
                <c:formatCode>General</c:formatCode>
                <c:ptCount val="11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6BE-4C03-B429-2E6E50C533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765248"/>
        <c:axId val="115766784"/>
      </c:scatterChart>
      <c:valAx>
        <c:axId val="115765248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115766784"/>
        <c:crosses val="autoZero"/>
        <c:crossBetween val="midCat"/>
        <c:majorUnit val="1"/>
      </c:valAx>
      <c:valAx>
        <c:axId val="115766784"/>
        <c:scaling>
          <c:orientation val="minMax"/>
          <c:max val="400"/>
          <c:min val="-4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115765248"/>
        <c:crossesAt val="0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7</c:f>
                <c:numCache>
                  <c:formatCode>General</c:formatCode>
                  <c:ptCount val="16"/>
                  <c:pt idx="0">
                    <c:v>0.74990000000000001</c:v>
                  </c:pt>
                  <c:pt idx="1">
                    <c:v>0.74370000000000003</c:v>
                  </c:pt>
                  <c:pt idx="2">
                    <c:v>0.75660000000000005</c:v>
                  </c:pt>
                  <c:pt idx="3">
                    <c:v>0.92959999999999998</c:v>
                  </c:pt>
                  <c:pt idx="4">
                    <c:v>0.94199999999999995</c:v>
                  </c:pt>
                </c:numCache>
              </c:numRef>
            </c:plus>
            <c:minus>
              <c:numRef>
                <c:f>Sheet2!$F$2:$F$17</c:f>
                <c:numCache>
                  <c:formatCode>General</c:formatCode>
                  <c:ptCount val="16"/>
                  <c:pt idx="0">
                    <c:v>0.74990000000000001</c:v>
                  </c:pt>
                  <c:pt idx="1">
                    <c:v>0.74370000000000003</c:v>
                  </c:pt>
                  <c:pt idx="2">
                    <c:v>0.75660000000000005</c:v>
                  </c:pt>
                  <c:pt idx="3">
                    <c:v>0.92959999999999998</c:v>
                  </c:pt>
                  <c:pt idx="4">
                    <c:v>0.94199999999999995</c:v>
                  </c:pt>
                </c:numCache>
              </c:numRef>
            </c:minus>
          </c:errBars>
          <c:xVal>
            <c:numRef>
              <c:f>Sheet2!$J$2:$J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  <c:pt idx="4">
                  <c:v>4.3</c:v>
                </c:pt>
              </c:numCache>
            </c:numRef>
          </c:xVal>
          <c:yVal>
            <c:numRef>
              <c:f>Sheet2!$B$2:$B$17</c:f>
              <c:numCache>
                <c:formatCode>General</c:formatCode>
                <c:ptCount val="16"/>
                <c:pt idx="0">
                  <c:v>4.8376999999999999</c:v>
                </c:pt>
                <c:pt idx="1">
                  <c:v>1.6387</c:v>
                </c:pt>
                <c:pt idx="2">
                  <c:v>0.54490000000000005</c:v>
                </c:pt>
                <c:pt idx="3">
                  <c:v>-2.7686999999999999</c:v>
                </c:pt>
                <c:pt idx="4">
                  <c:v>-9.64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0C0-42B3-8F1A-21CAF027F27E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7</c:f>
                <c:numCache>
                  <c:formatCode>General</c:formatCode>
                  <c:ptCount val="16"/>
                  <c:pt idx="0">
                    <c:v>0.95430000000000004</c:v>
                  </c:pt>
                  <c:pt idx="1">
                    <c:v>0.90790000000000004</c:v>
                  </c:pt>
                  <c:pt idx="2">
                    <c:v>0.83179999999999998</c:v>
                  </c:pt>
                  <c:pt idx="3">
                    <c:v>1.1929000000000001</c:v>
                  </c:pt>
                  <c:pt idx="4">
                    <c:v>1.2033</c:v>
                  </c:pt>
                </c:numCache>
              </c:numRef>
            </c:plus>
            <c:minus>
              <c:numRef>
                <c:f>Sheet2!$G$2:$G$17</c:f>
                <c:numCache>
                  <c:formatCode>General</c:formatCode>
                  <c:ptCount val="16"/>
                  <c:pt idx="0">
                    <c:v>0.95430000000000004</c:v>
                  </c:pt>
                  <c:pt idx="1">
                    <c:v>0.90790000000000004</c:v>
                  </c:pt>
                  <c:pt idx="2">
                    <c:v>0.83179999999999998</c:v>
                  </c:pt>
                  <c:pt idx="3">
                    <c:v>1.1929000000000001</c:v>
                  </c:pt>
                  <c:pt idx="4">
                    <c:v>1.2033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</c:numCache>
            </c:numRef>
          </c:xVal>
          <c:yVal>
            <c:numRef>
              <c:f>Sheet2!$C$2:$C$17</c:f>
              <c:numCache>
                <c:formatCode>General</c:formatCode>
                <c:ptCount val="16"/>
                <c:pt idx="0">
                  <c:v>5.3769999999999998</c:v>
                </c:pt>
                <c:pt idx="1">
                  <c:v>3.4853999999999998</c:v>
                </c:pt>
                <c:pt idx="2">
                  <c:v>1.0564</c:v>
                </c:pt>
                <c:pt idx="3">
                  <c:v>0.17399999999999999</c:v>
                </c:pt>
                <c:pt idx="4">
                  <c:v>-6.35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0C0-42B3-8F1A-21CAF027F27E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17</c:f>
                <c:numCache>
                  <c:formatCode>General</c:formatCode>
                  <c:ptCount val="16"/>
                  <c:pt idx="0">
                    <c:v>0.64700000000000002</c:v>
                  </c:pt>
                  <c:pt idx="1">
                    <c:v>0.94130000000000003</c:v>
                  </c:pt>
                  <c:pt idx="2">
                    <c:v>1.0012000000000001</c:v>
                  </c:pt>
                  <c:pt idx="3">
                    <c:v>1.3575999999999999</c:v>
                  </c:pt>
                  <c:pt idx="4">
                    <c:v>1.7295</c:v>
                  </c:pt>
                </c:numCache>
              </c:numRef>
            </c:plus>
            <c:minus>
              <c:numRef>
                <c:f>Sheet2!$H$2:$H$17</c:f>
                <c:numCache>
                  <c:formatCode>General</c:formatCode>
                  <c:ptCount val="16"/>
                  <c:pt idx="0">
                    <c:v>0.64700000000000002</c:v>
                  </c:pt>
                  <c:pt idx="1">
                    <c:v>0.94130000000000003</c:v>
                  </c:pt>
                  <c:pt idx="2">
                    <c:v>1.0012000000000001</c:v>
                  </c:pt>
                  <c:pt idx="3">
                    <c:v>1.3575999999999999</c:v>
                  </c:pt>
                  <c:pt idx="4">
                    <c:v>1.7295</c:v>
                  </c:pt>
                </c:numCache>
              </c:numRef>
            </c:minus>
          </c:errBars>
          <c:xVal>
            <c:numRef>
              <c:f>Sheet2!$L$2:$L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  <c:pt idx="4">
                  <c:v>4.7</c:v>
                </c:pt>
              </c:numCache>
            </c:numRef>
          </c:xVal>
          <c:yVal>
            <c:numRef>
              <c:f>Sheet2!$D$2:$D$17</c:f>
              <c:numCache>
                <c:formatCode>General</c:formatCode>
                <c:ptCount val="16"/>
                <c:pt idx="0">
                  <c:v>6.9671000000000003</c:v>
                </c:pt>
                <c:pt idx="1">
                  <c:v>5.0487000000000002</c:v>
                </c:pt>
                <c:pt idx="2">
                  <c:v>2.5918999999999999</c:v>
                </c:pt>
                <c:pt idx="3">
                  <c:v>0.34460000000000002</c:v>
                </c:pt>
                <c:pt idx="4">
                  <c:v>-5.4554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0C0-42B3-8F1A-21CAF027F27E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circle"/>
            <c:size val="9"/>
          </c:marker>
          <c:errBars>
            <c:errDir val="y"/>
            <c:errBarType val="both"/>
            <c:errValType val="cust"/>
            <c:noEndCap val="0"/>
            <c:plus>
              <c:numRef>
                <c:f>Sheet2!$I$2:$I$17</c:f>
                <c:numCache>
                  <c:formatCode>General</c:formatCode>
                  <c:ptCount val="16"/>
                </c:numCache>
              </c:numRef>
            </c:plus>
            <c:minus>
              <c:numRef>
                <c:f>Sheet2!$I$2:$I$17</c:f>
                <c:numCache>
                  <c:formatCode>General</c:formatCode>
                  <c:ptCount val="16"/>
                </c:numCache>
              </c:numRef>
            </c:minus>
          </c:errBars>
          <c:xVal>
            <c:numRef>
              <c:f>Sheet2!$M$2:$M$17</c:f>
              <c:numCache>
                <c:formatCode>General</c:formatCode>
                <c:ptCount val="16"/>
              </c:numCache>
            </c:numRef>
          </c:xVal>
          <c:yVal>
            <c:numRef>
              <c:f>Sheet2!$E$2:$E$17</c:f>
              <c:numCache>
                <c:formatCode>General</c:formatCode>
                <c:ptCount val="16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0C0-42B3-8F1A-21CAF027F2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4107520"/>
        <c:axId val="114108672"/>
      </c:scatterChart>
      <c:valAx>
        <c:axId val="114107520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114108672"/>
        <c:crosses val="autoZero"/>
        <c:crossBetween val="midCat"/>
        <c:majorUnit val="1"/>
      </c:valAx>
      <c:valAx>
        <c:axId val="114108672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114107520"/>
        <c:crossesAt val="0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7</c:f>
                <c:numCache>
                  <c:formatCode>General</c:formatCode>
                  <c:ptCount val="16"/>
                  <c:pt idx="0">
                    <c:v>0.13550000000000001</c:v>
                  </c:pt>
                  <c:pt idx="1">
                    <c:v>7.7399999999999997E-2</c:v>
                  </c:pt>
                  <c:pt idx="2">
                    <c:v>6.8199999999999997E-2</c:v>
                  </c:pt>
                  <c:pt idx="3">
                    <c:v>7.6999999999999999E-2</c:v>
                  </c:pt>
                </c:numCache>
              </c:numRef>
            </c:plus>
            <c:minus>
              <c:numRef>
                <c:f>Sheet2!$F$2:$F$17</c:f>
                <c:numCache>
                  <c:formatCode>General</c:formatCode>
                  <c:ptCount val="16"/>
                  <c:pt idx="0">
                    <c:v>0.13550000000000001</c:v>
                  </c:pt>
                  <c:pt idx="1">
                    <c:v>7.7399999999999997E-2</c:v>
                  </c:pt>
                  <c:pt idx="2">
                    <c:v>6.8199999999999997E-2</c:v>
                  </c:pt>
                  <c:pt idx="3">
                    <c:v>7.6999999999999999E-2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</c:numCache>
            </c:numRef>
          </c:xVal>
          <c:yVal>
            <c:numRef>
              <c:f>Sheet2!$B$2:$B$17</c:f>
              <c:numCache>
                <c:formatCode>General</c:formatCode>
                <c:ptCount val="16"/>
                <c:pt idx="0">
                  <c:v>0.97199999999999998</c:v>
                </c:pt>
                <c:pt idx="1">
                  <c:v>0.36370000000000002</c:v>
                </c:pt>
                <c:pt idx="2">
                  <c:v>-2.1100000000000001E-2</c:v>
                </c:pt>
                <c:pt idx="3">
                  <c:v>-0.601400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638-4367-AE0F-2BCF82BDC1F4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7</c:f>
                <c:numCache>
                  <c:formatCode>General</c:formatCode>
                  <c:ptCount val="16"/>
                  <c:pt idx="0">
                    <c:v>0.152</c:v>
                  </c:pt>
                  <c:pt idx="1">
                    <c:v>9.5399999999999999E-2</c:v>
                  </c:pt>
                  <c:pt idx="2">
                    <c:v>7.0099999999999996E-2</c:v>
                  </c:pt>
                  <c:pt idx="3">
                    <c:v>8.4900000000000003E-2</c:v>
                  </c:pt>
                </c:numCache>
              </c:numRef>
            </c:plus>
            <c:minus>
              <c:numRef>
                <c:f>Sheet2!$G$2:$G$17</c:f>
                <c:numCache>
                  <c:formatCode>General</c:formatCode>
                  <c:ptCount val="16"/>
                  <c:pt idx="0">
                    <c:v>0.152</c:v>
                  </c:pt>
                  <c:pt idx="1">
                    <c:v>9.5399999999999999E-2</c:v>
                  </c:pt>
                  <c:pt idx="2">
                    <c:v>7.0099999999999996E-2</c:v>
                  </c:pt>
                  <c:pt idx="3">
                    <c:v>8.4900000000000003E-2</c:v>
                  </c:pt>
                </c:numCache>
              </c:numRef>
            </c:minus>
          </c:errBars>
          <c:xVal>
            <c:numRef>
              <c:f>Sheet2!$L$2:$L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xVal>
          <c:yVal>
            <c:numRef>
              <c:f>Sheet2!$C$2:$C$17</c:f>
              <c:numCache>
                <c:formatCode>General</c:formatCode>
                <c:ptCount val="16"/>
                <c:pt idx="0">
                  <c:v>1.0004</c:v>
                </c:pt>
                <c:pt idx="1">
                  <c:v>0.43580000000000002</c:v>
                </c:pt>
                <c:pt idx="2">
                  <c:v>0.1043</c:v>
                </c:pt>
                <c:pt idx="3">
                  <c:v>-0.5974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638-4367-AE0F-2BCF82BDC1F4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 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17</c:f>
                <c:numCache>
                  <c:formatCode>General</c:formatCode>
                  <c:ptCount val="16"/>
                  <c:pt idx="0">
                    <c:v>0.14280000000000001</c:v>
                  </c:pt>
                  <c:pt idx="1">
                    <c:v>0.1019</c:v>
                  </c:pt>
                  <c:pt idx="2">
                    <c:v>9.2100000000000001E-2</c:v>
                  </c:pt>
                  <c:pt idx="3">
                    <c:v>9.1899999999999996E-2</c:v>
                  </c:pt>
                </c:numCache>
              </c:numRef>
            </c:plus>
            <c:minus>
              <c:numRef>
                <c:f>Sheet2!$H$2:$H$17</c:f>
                <c:numCache>
                  <c:formatCode>General</c:formatCode>
                  <c:ptCount val="16"/>
                  <c:pt idx="0">
                    <c:v>0.14280000000000001</c:v>
                  </c:pt>
                  <c:pt idx="1">
                    <c:v>0.1019</c:v>
                  </c:pt>
                  <c:pt idx="2">
                    <c:v>9.2100000000000001E-2</c:v>
                  </c:pt>
                  <c:pt idx="3">
                    <c:v>9.1899999999999996E-2</c:v>
                  </c:pt>
                </c:numCache>
              </c:numRef>
            </c:minus>
          </c:errBars>
          <c:xVal>
            <c:numRef>
              <c:f>Sheet2!$M$2:$M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</c:numCache>
            </c:numRef>
          </c:xVal>
          <c:yVal>
            <c:numRef>
              <c:f>Sheet2!$D$2:$D$17</c:f>
              <c:numCache>
                <c:formatCode>General</c:formatCode>
                <c:ptCount val="16"/>
                <c:pt idx="0">
                  <c:v>1.1333</c:v>
                </c:pt>
                <c:pt idx="1">
                  <c:v>0.57620000000000005</c:v>
                </c:pt>
                <c:pt idx="2">
                  <c:v>0.1966</c:v>
                </c:pt>
                <c:pt idx="3">
                  <c:v>-0.590300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638-4367-AE0F-2BCF82BDC1F4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circle"/>
            <c:size val="9"/>
          </c:marker>
          <c:errBars>
            <c:errDir val="y"/>
            <c:errBarType val="both"/>
            <c:errValType val="cust"/>
            <c:noEndCap val="0"/>
            <c:plus>
              <c:numRef>
                <c:f>Sheet2!$I$2:$I$17</c:f>
                <c:numCache>
                  <c:formatCode>General</c:formatCode>
                  <c:ptCount val="16"/>
                </c:numCache>
              </c:numRef>
            </c:plus>
            <c:minus>
              <c:numRef>
                <c:f>Sheet2!$I$2:$I$17</c:f>
                <c:numCache>
                  <c:formatCode>General</c:formatCode>
                  <c:ptCount val="16"/>
                </c:numCache>
              </c:numRef>
            </c:minus>
          </c:errBars>
          <c:xVal>
            <c:numRef>
              <c:f>Sheet2!$N$2:$N$17</c:f>
              <c:numCache>
                <c:formatCode>General</c:formatCode>
                <c:ptCount val="16"/>
              </c:numCache>
            </c:numRef>
          </c:xVal>
          <c:yVal>
            <c:numRef>
              <c:f>Sheet2!$E$2:$E$17</c:f>
              <c:numCache>
                <c:formatCode>General</c:formatCode>
                <c:ptCount val="16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638-4367-AE0F-2BCF82BDC1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073984"/>
        <c:axId val="116075520"/>
      </c:scatterChart>
      <c:valAx>
        <c:axId val="116073984"/>
        <c:scaling>
          <c:orientation val="minMax"/>
          <c:max val="4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116075520"/>
        <c:crosses val="autoZero"/>
        <c:crossBetween val="midCat"/>
        <c:majorUnit val="1"/>
      </c:valAx>
      <c:valAx>
        <c:axId val="116075520"/>
        <c:scaling>
          <c:orientation val="minMax"/>
          <c:max val="2.5"/>
          <c:min val="-2.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116073984"/>
        <c:crossesAt val="0"/>
        <c:crossBetween val="midCat"/>
        <c:majorUnit val="0.5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C6824E-4100-4498-B321-81201D293208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1143000" y="685800"/>
            <a:ext cx="9144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DB71BF-8306-4D20-9C13-3995AC0788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727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1143000" y="685800"/>
            <a:ext cx="9144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: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justed 1 month change in </a:t>
            </a:r>
            <a:r>
              <a:rPr lang="en-US" sz="1200" b="1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moglobin, TSAT, and Ferritin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rom before to after IV iron dosing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72D4C8-8573-4530-8B8E-ACFA713CD1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127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130430"/>
            <a:ext cx="155448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43200" y="3886200"/>
            <a:ext cx="128016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258800" y="274639"/>
            <a:ext cx="41148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0" y="274639"/>
            <a:ext cx="120396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26" y="4406905"/>
            <a:ext cx="155448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4626" y="2906713"/>
            <a:ext cx="155448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400" y="1600204"/>
            <a:ext cx="80772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96400" y="1600204"/>
            <a:ext cx="80772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535113"/>
            <a:ext cx="808037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4400" y="2174875"/>
            <a:ext cx="808037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90055" y="1535113"/>
            <a:ext cx="808355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90055" y="2174875"/>
            <a:ext cx="808355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5" y="273050"/>
            <a:ext cx="601662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50100" y="273052"/>
            <a:ext cx="1022350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5" y="1435102"/>
            <a:ext cx="601662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76" y="4800600"/>
            <a:ext cx="109728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84576" y="612775"/>
            <a:ext cx="109728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76" y="5367338"/>
            <a:ext cx="109728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8"/>
            <a:ext cx="164592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4"/>
            <a:ext cx="164592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4400" y="6356355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48400" y="6356355"/>
            <a:ext cx="5791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06400" y="6356355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3789675853"/>
              </p:ext>
            </p:extLst>
          </p:nvPr>
        </p:nvGraphicFramePr>
        <p:xfrm>
          <a:off x="12268200" y="923330"/>
          <a:ext cx="5867400" cy="4797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3552989789"/>
              </p:ext>
            </p:extLst>
          </p:nvPr>
        </p:nvGraphicFramePr>
        <p:xfrm>
          <a:off x="6468905" y="923330"/>
          <a:ext cx="5628234" cy="4801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2377787040"/>
              </p:ext>
            </p:extLst>
          </p:nvPr>
        </p:nvGraphicFramePr>
        <p:xfrm>
          <a:off x="1219200" y="923330"/>
          <a:ext cx="4780383" cy="4797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6200" y="461665"/>
            <a:ext cx="2805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err="1" smtClean="0">
                <a:solidFill>
                  <a:prstClr val="black"/>
                </a:solidFill>
              </a:rPr>
              <a:t>Hgb</a:t>
            </a:r>
            <a:r>
              <a:rPr lang="en-US" sz="2400" dirty="0" smtClean="0">
                <a:solidFill>
                  <a:prstClr val="black"/>
                </a:solidFill>
              </a:rPr>
              <a:t> </a:t>
            </a:r>
            <a:r>
              <a:rPr lang="en-US" sz="2400" dirty="0">
                <a:solidFill>
                  <a:prstClr val="black"/>
                </a:solidFill>
              </a:rPr>
              <a:t>(g/</a:t>
            </a:r>
            <a:r>
              <a:rPr lang="en-US" sz="2400" dirty="0" err="1">
                <a:solidFill>
                  <a:prstClr val="black"/>
                </a:solidFill>
              </a:rPr>
              <a:t>dL</a:t>
            </a:r>
            <a:r>
              <a:rPr lang="en-US" sz="2400" dirty="0">
                <a:solidFill>
                  <a:prstClr val="black"/>
                </a:solidFill>
              </a:rPr>
              <a:t>)</a:t>
            </a:r>
          </a:p>
        </p:txBody>
      </p:sp>
      <p:sp useBgFill="1">
        <p:nvSpPr>
          <p:cNvPr id="9" name="TextBox 8"/>
          <p:cNvSpPr txBox="1"/>
          <p:nvPr/>
        </p:nvSpPr>
        <p:spPr>
          <a:xfrm>
            <a:off x="2133600" y="5720693"/>
            <a:ext cx="37338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Hemoglobin (month 0)</a:t>
            </a:r>
            <a:endParaRPr lang="en-US" sz="2800" dirty="0"/>
          </a:p>
        </p:txBody>
      </p:sp>
      <p:sp useBgFill="1">
        <p:nvSpPr>
          <p:cNvPr id="10" name="TextBox 9"/>
          <p:cNvSpPr txBox="1"/>
          <p:nvPr/>
        </p:nvSpPr>
        <p:spPr>
          <a:xfrm>
            <a:off x="8305800" y="5720693"/>
            <a:ext cx="27432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TSAT (month 0)</a:t>
            </a:r>
            <a:endParaRPr lang="en-US" sz="2800" dirty="0"/>
          </a:p>
        </p:txBody>
      </p:sp>
      <p:sp useBgFill="1">
        <p:nvSpPr>
          <p:cNvPr id="11" name="TextBox 10"/>
          <p:cNvSpPr txBox="1"/>
          <p:nvPr/>
        </p:nvSpPr>
        <p:spPr>
          <a:xfrm>
            <a:off x="14097000" y="5725180"/>
            <a:ext cx="33528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Ferritin (month 0)</a:t>
            </a:r>
            <a:endParaRPr lang="en-US" sz="2800" dirty="0"/>
          </a:p>
        </p:txBody>
      </p:sp>
      <p:sp>
        <p:nvSpPr>
          <p:cNvPr id="16" name="TextBox 15"/>
          <p:cNvSpPr txBox="1"/>
          <p:nvPr/>
        </p:nvSpPr>
        <p:spPr>
          <a:xfrm>
            <a:off x="76200" y="6243935"/>
            <a:ext cx="1905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 smtClean="0"/>
              <a:t>Strata: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1618611"/>
              </p:ext>
            </p:extLst>
          </p:nvPr>
        </p:nvGraphicFramePr>
        <p:xfrm>
          <a:off x="1828800" y="6268850"/>
          <a:ext cx="1645920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28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098612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958788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1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0-&lt;1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1-&lt;12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2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2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>
                          <a:effectLst/>
                        </a:rPr>
                        <a:t>20-24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>
                          <a:effectLst/>
                        </a:rPr>
                        <a:t>25-29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30-34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35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20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200-4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500-7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800-11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200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5091" y="17834"/>
            <a:ext cx="61682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 smtClean="0"/>
              <a:t>1-month </a:t>
            </a:r>
            <a:r>
              <a:rPr lang="en-US" sz="2400" dirty="0"/>
              <a:t>IV iron dose (expressed as </a:t>
            </a:r>
            <a:r>
              <a:rPr lang="en-US" sz="2400" dirty="0" smtClean="0"/>
              <a:t>mg/month):</a:t>
            </a:r>
            <a:endParaRPr lang="en-US" sz="2400" dirty="0"/>
          </a:p>
        </p:txBody>
      </p:sp>
      <p:sp>
        <p:nvSpPr>
          <p:cNvPr id="15" name="TextBox 14"/>
          <p:cNvSpPr txBox="1"/>
          <p:nvPr/>
        </p:nvSpPr>
        <p:spPr>
          <a:xfrm>
            <a:off x="6134370" y="457200"/>
            <a:ext cx="25524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smtClean="0">
                <a:solidFill>
                  <a:prstClr val="black"/>
                </a:solidFill>
              </a:rPr>
              <a:t>TSAT (%)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159090" y="457200"/>
            <a:ext cx="34619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smtClean="0">
                <a:solidFill>
                  <a:prstClr val="black"/>
                </a:solidFill>
              </a:rPr>
              <a:t>Ferritin (ng/mL)</a:t>
            </a:r>
            <a:endParaRPr lang="en-US" sz="2400" dirty="0">
              <a:solidFill>
                <a:prstClr val="black"/>
              </a:solidFill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7880499" y="76200"/>
            <a:ext cx="4235301" cy="466993"/>
            <a:chOff x="7880499" y="76200"/>
            <a:chExt cx="4235301" cy="466993"/>
          </a:xfrm>
        </p:grpSpPr>
        <p:sp>
          <p:nvSpPr>
            <p:cNvPr id="4" name="TextBox 3"/>
            <p:cNvSpPr txBox="1"/>
            <p:nvPr/>
          </p:nvSpPr>
          <p:spPr>
            <a:xfrm>
              <a:off x="8077200" y="81528"/>
              <a:ext cx="196399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 smtClean="0"/>
                <a:t>0-dose (None)</a:t>
              </a:r>
              <a:endParaRPr lang="en-US" sz="24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228001" y="76200"/>
              <a:ext cx="8050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 smtClean="0"/>
                <a:t>&lt;300</a:t>
              </a:r>
              <a:endParaRPr lang="en-US" sz="24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1310771" y="76200"/>
              <a:ext cx="8050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≥</a:t>
              </a:r>
              <a:r>
                <a:rPr lang="en-US" sz="2400" dirty="0" smtClean="0"/>
                <a:t>300</a:t>
              </a:r>
              <a:endParaRPr lang="en-US" sz="2400" dirty="0"/>
            </a:p>
          </p:txBody>
        </p:sp>
        <p:sp>
          <p:nvSpPr>
            <p:cNvPr id="7" name="Diamond 6"/>
            <p:cNvSpPr/>
            <p:nvPr/>
          </p:nvSpPr>
          <p:spPr>
            <a:xfrm>
              <a:off x="7880499" y="196701"/>
              <a:ext cx="228600" cy="230833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0100198" y="194932"/>
              <a:ext cx="186802" cy="2308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Isosceles Triangle 23"/>
            <p:cNvSpPr/>
            <p:nvPr/>
          </p:nvSpPr>
          <p:spPr>
            <a:xfrm>
              <a:off x="11076059" y="184299"/>
              <a:ext cx="277741" cy="230833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51183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7</TotalTime>
  <Words>98</Words>
  <Application>Microsoft Office PowerPoint</Application>
  <PresentationFormat>Custom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Larkina</dc:creator>
  <cp:lastModifiedBy>J McCready-Maynes</cp:lastModifiedBy>
  <cp:revision>79</cp:revision>
  <dcterms:created xsi:type="dcterms:W3CDTF">2006-08-16T00:00:00Z</dcterms:created>
  <dcterms:modified xsi:type="dcterms:W3CDTF">2017-05-08T14:53:40Z</dcterms:modified>
</cp:coreProperties>
</file>